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355" r:id="rId2"/>
  </p:sldIdLst>
  <p:sldSz cx="9144000" cy="6858000" type="screen4x3"/>
  <p:notesSz cx="9926638" cy="679767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725" autoAdjust="0"/>
    <p:restoredTop sz="94660"/>
  </p:normalViewPr>
  <p:slideViewPr>
    <p:cSldViewPr snapToGrid="0">
      <p:cViewPr>
        <p:scale>
          <a:sx n="75" d="100"/>
          <a:sy n="75" d="100"/>
        </p:scale>
        <p:origin x="1284" y="1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212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%20Koyama\Desktop\2019%20plant%20methods\2017%20&#26681;&#31665;&#12288;&#21697;&#31278;%202019.10.25&#35299;&#2651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%20Koyama\Desktop\2019%20plant%20methods\2017%20&#26681;&#31665;&#12288;&#21697;&#31278;%202019.10.25&#35299;&#26512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358732608989757"/>
          <c:y val="1.6012450922973473E-2"/>
          <c:w val="0.79713862816318981"/>
          <c:h val="0.92982733563263265"/>
        </c:manualLayout>
      </c:layout>
      <c:scatterChart>
        <c:scatterStyle val="lineMarker"/>
        <c:varyColors val="0"/>
        <c:ser>
          <c:idx val="1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'感染根長、表面積　乾物　201210'!$J$39:$J$74</c:f>
              <c:numCache>
                <c:formatCode>General</c:formatCode>
                <c:ptCount val="36"/>
                <c:pt idx="0">
                  <c:v>8.5714285714285712</c:v>
                </c:pt>
                <c:pt idx="1">
                  <c:v>5.7142857142857144</c:v>
                </c:pt>
                <c:pt idx="2">
                  <c:v>14.705882352941178</c:v>
                </c:pt>
                <c:pt idx="3">
                  <c:v>18.421052631578945</c:v>
                </c:pt>
                <c:pt idx="4">
                  <c:v>33.333333333333329</c:v>
                </c:pt>
                <c:pt idx="5">
                  <c:v>53.846153846153847</c:v>
                </c:pt>
                <c:pt idx="6">
                  <c:v>17.142857142857142</c:v>
                </c:pt>
                <c:pt idx="7">
                  <c:v>53.125</c:v>
                </c:pt>
                <c:pt idx="8">
                  <c:v>11.428571428571429</c:v>
                </c:pt>
                <c:pt idx="9">
                  <c:v>87.5</c:v>
                </c:pt>
                <c:pt idx="10">
                  <c:v>67.346938775510196</c:v>
                </c:pt>
                <c:pt idx="11">
                  <c:v>12.5</c:v>
                </c:pt>
                <c:pt idx="12">
                  <c:v>84.848484848484844</c:v>
                </c:pt>
                <c:pt idx="13">
                  <c:v>90.909090909090907</c:v>
                </c:pt>
                <c:pt idx="14">
                  <c:v>66.666666666666657</c:v>
                </c:pt>
                <c:pt idx="15">
                  <c:v>40</c:v>
                </c:pt>
                <c:pt idx="16">
                  <c:v>93.75</c:v>
                </c:pt>
                <c:pt idx="17">
                  <c:v>88.571428571428569</c:v>
                </c:pt>
                <c:pt idx="18">
                  <c:v>47.058823529411761</c:v>
                </c:pt>
                <c:pt idx="19">
                  <c:v>0</c:v>
                </c:pt>
                <c:pt idx="20">
                  <c:v>5</c:v>
                </c:pt>
                <c:pt idx="21">
                  <c:v>21.875</c:v>
                </c:pt>
                <c:pt idx="22">
                  <c:v>76.19047619047619</c:v>
                </c:pt>
                <c:pt idx="23">
                  <c:v>63.636363636363633</c:v>
                </c:pt>
                <c:pt idx="24">
                  <c:v>68.421052631578945</c:v>
                </c:pt>
                <c:pt idx="25">
                  <c:v>89.130434782608688</c:v>
                </c:pt>
                <c:pt idx="26">
                  <c:v>93.181818181818173</c:v>
                </c:pt>
                <c:pt idx="27">
                  <c:v>2.1739130434782608</c:v>
                </c:pt>
                <c:pt idx="28">
                  <c:v>0</c:v>
                </c:pt>
                <c:pt idx="29">
                  <c:v>8</c:v>
                </c:pt>
                <c:pt idx="30">
                  <c:v>23.913043478260871</c:v>
                </c:pt>
                <c:pt idx="31">
                  <c:v>0</c:v>
                </c:pt>
                <c:pt idx="32">
                  <c:v>0</c:v>
                </c:pt>
                <c:pt idx="33">
                  <c:v>26</c:v>
                </c:pt>
                <c:pt idx="34">
                  <c:v>0</c:v>
                </c:pt>
                <c:pt idx="35">
                  <c:v>0</c:v>
                </c:pt>
              </c:numCache>
            </c:numRef>
          </c:xVal>
          <c:yVal>
            <c:numRef>
              <c:f>'感染根長、表面積　乾物　201210'!$X$39:$X$74</c:f>
              <c:numCache>
                <c:formatCode>General</c:formatCode>
                <c:ptCount val="36"/>
                <c:pt idx="0">
                  <c:v>-31.775000000000006</c:v>
                </c:pt>
                <c:pt idx="1">
                  <c:v>-9.6924999999998818E-2</c:v>
                </c:pt>
                <c:pt idx="2">
                  <c:v>40.509399999999999</c:v>
                </c:pt>
                <c:pt idx="3">
                  <c:v>-5.0803999999999974</c:v>
                </c:pt>
                <c:pt idx="4">
                  <c:v>-7.0069000000000017</c:v>
                </c:pt>
                <c:pt idx="5">
                  <c:v>33.853700000000018</c:v>
                </c:pt>
                <c:pt idx="6">
                  <c:v>-21.19905</c:v>
                </c:pt>
                <c:pt idx="7">
                  <c:v>-7.4637249999999966</c:v>
                </c:pt>
                <c:pt idx="8">
                  <c:v>20.867750000000001</c:v>
                </c:pt>
                <c:pt idx="9">
                  <c:v>-14.844800000000006</c:v>
                </c:pt>
                <c:pt idx="10">
                  <c:v>10.984874999999988</c:v>
                </c:pt>
                <c:pt idx="11">
                  <c:v>37.106799999999993</c:v>
                </c:pt>
                <c:pt idx="12">
                  <c:v>12.220299999999995</c:v>
                </c:pt>
                <c:pt idx="13">
                  <c:v>42.002700000000004</c:v>
                </c:pt>
                <c:pt idx="14">
                  <c:v>28.859400000000008</c:v>
                </c:pt>
                <c:pt idx="15">
                  <c:v>6.3941499999999962</c:v>
                </c:pt>
                <c:pt idx="16">
                  <c:v>29.095675</c:v>
                </c:pt>
                <c:pt idx="17">
                  <c:v>57.193849999999998</c:v>
                </c:pt>
                <c:pt idx="18">
                  <c:v>-1.4490000000000052</c:v>
                </c:pt>
                <c:pt idx="19">
                  <c:v>12.819074999999998</c:v>
                </c:pt>
                <c:pt idx="20">
                  <c:v>-21.021100000000004</c:v>
                </c:pt>
                <c:pt idx="21">
                  <c:v>-26.959999999999994</c:v>
                </c:pt>
                <c:pt idx="22">
                  <c:v>1.9880999999999887</c:v>
                </c:pt>
                <c:pt idx="23">
                  <c:v>9.1260000000000048</c:v>
                </c:pt>
                <c:pt idx="24">
                  <c:v>-11.768649999999994</c:v>
                </c:pt>
                <c:pt idx="25">
                  <c:v>9.0211749999999995</c:v>
                </c:pt>
                <c:pt idx="26">
                  <c:v>-22.971249999999998</c:v>
                </c:pt>
                <c:pt idx="27">
                  <c:v>48.068799999999996</c:v>
                </c:pt>
                <c:pt idx="28">
                  <c:v>-23.707025000000009</c:v>
                </c:pt>
                <c:pt idx="29">
                  <c:v>-56.595100000000009</c:v>
                </c:pt>
                <c:pt idx="30">
                  <c:v>19.820099999999996</c:v>
                </c:pt>
                <c:pt idx="31">
                  <c:v>-36.983900000000006</c:v>
                </c:pt>
                <c:pt idx="32">
                  <c:v>-71.839100000000002</c:v>
                </c:pt>
                <c:pt idx="33">
                  <c:v>26.573549999999997</c:v>
                </c:pt>
                <c:pt idx="34">
                  <c:v>-30.653125000000003</c:v>
                </c:pt>
                <c:pt idx="35">
                  <c:v>-55.09035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F0D-4DCD-800E-10C76F2659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69123616"/>
        <c:axId val="2069115296"/>
      </c:scatterChart>
      <c:valAx>
        <c:axId val="2069123616"/>
        <c:scaling>
          <c:orientation val="minMax"/>
          <c:max val="10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69115296"/>
        <c:crosses val="autoZero"/>
        <c:crossBetween val="midCat"/>
        <c:majorUnit val="25"/>
      </c:valAx>
      <c:valAx>
        <c:axId val="2069115296"/>
        <c:scaling>
          <c:orientation val="minMax"/>
          <c:max val="100"/>
          <c:min val="-8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69123616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5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358732608989757"/>
          <c:y val="1.6012450922973473E-2"/>
          <c:w val="0.79713862816318981"/>
          <c:h val="0.92982733563263265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270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0"/>
            <c:dispEq val="0"/>
          </c:trendline>
          <c:xVal>
            <c:numRef>
              <c:f>'感染根長、表面積　乾物　201210'!$J$3:$J$38</c:f>
              <c:numCache>
                <c:formatCode>General</c:formatCode>
                <c:ptCount val="36"/>
                <c:pt idx="0">
                  <c:v>0</c:v>
                </c:pt>
                <c:pt idx="1">
                  <c:v>12.121212121212121</c:v>
                </c:pt>
                <c:pt idx="2">
                  <c:v>44.444444444444443</c:v>
                </c:pt>
                <c:pt idx="3">
                  <c:v>96.774193548387103</c:v>
                </c:pt>
                <c:pt idx="4">
                  <c:v>93.333333333333329</c:v>
                </c:pt>
                <c:pt idx="5">
                  <c:v>84</c:v>
                </c:pt>
                <c:pt idx="6">
                  <c:v>13.793103448275861</c:v>
                </c:pt>
                <c:pt idx="7">
                  <c:v>73.333333333333329</c:v>
                </c:pt>
                <c:pt idx="8">
                  <c:v>100</c:v>
                </c:pt>
                <c:pt idx="9">
                  <c:v>40</c:v>
                </c:pt>
                <c:pt idx="10">
                  <c:v>62.068965517241381</c:v>
                </c:pt>
                <c:pt idx="11">
                  <c:v>65.384615384615387</c:v>
                </c:pt>
                <c:pt idx="12">
                  <c:v>96.15384615384616</c:v>
                </c:pt>
                <c:pt idx="13">
                  <c:v>97.435897435897431</c:v>
                </c:pt>
                <c:pt idx="14">
                  <c:v>100</c:v>
                </c:pt>
                <c:pt idx="15">
                  <c:v>75</c:v>
                </c:pt>
                <c:pt idx="16">
                  <c:v>96.666666666666671</c:v>
                </c:pt>
                <c:pt idx="17">
                  <c:v>100</c:v>
                </c:pt>
                <c:pt idx="18">
                  <c:v>96.551724137931032</c:v>
                </c:pt>
                <c:pt idx="19">
                  <c:v>100</c:v>
                </c:pt>
                <c:pt idx="20">
                  <c:v>50</c:v>
                </c:pt>
                <c:pt idx="21">
                  <c:v>72.727272727272734</c:v>
                </c:pt>
                <c:pt idx="22">
                  <c:v>55.882352941176471</c:v>
                </c:pt>
                <c:pt idx="23">
                  <c:v>43.75</c:v>
                </c:pt>
                <c:pt idx="24">
                  <c:v>29.411764705882355</c:v>
                </c:pt>
                <c:pt idx="25">
                  <c:v>86.842105263157904</c:v>
                </c:pt>
                <c:pt idx="26">
                  <c:v>65.625</c:v>
                </c:pt>
                <c:pt idx="27">
                  <c:v>0</c:v>
                </c:pt>
                <c:pt idx="28">
                  <c:v>79.411764705882348</c:v>
                </c:pt>
                <c:pt idx="29">
                  <c:v>28.571428571428569</c:v>
                </c:pt>
                <c:pt idx="30">
                  <c:v>6.25</c:v>
                </c:pt>
                <c:pt idx="31">
                  <c:v>39.473684210526315</c:v>
                </c:pt>
                <c:pt idx="32">
                  <c:v>68.292682926829272</c:v>
                </c:pt>
                <c:pt idx="33">
                  <c:v>5.4054054054054053</c:v>
                </c:pt>
                <c:pt idx="34">
                  <c:v>6.666666666666667</c:v>
                </c:pt>
                <c:pt idx="35">
                  <c:v>5.7142857142857144</c:v>
                </c:pt>
              </c:numCache>
            </c:numRef>
          </c:xVal>
          <c:yVal>
            <c:numRef>
              <c:f>'感染根長、表面積　乾物　201210'!$X$3:$X$38</c:f>
              <c:numCache>
                <c:formatCode>General</c:formatCode>
                <c:ptCount val="36"/>
                <c:pt idx="0">
                  <c:v>-43.276274999999998</c:v>
                </c:pt>
                <c:pt idx="1">
                  <c:v>-21.755675000000004</c:v>
                </c:pt>
                <c:pt idx="2">
                  <c:v>27.270875</c:v>
                </c:pt>
                <c:pt idx="3">
                  <c:v>-33.441800000000001</c:v>
                </c:pt>
                <c:pt idx="4">
                  <c:v>-8.6714249999999993</c:v>
                </c:pt>
                <c:pt idx="5">
                  <c:v>57.930325000000011</c:v>
                </c:pt>
                <c:pt idx="6">
                  <c:v>-17.904099999999993</c:v>
                </c:pt>
                <c:pt idx="7">
                  <c:v>39.266675000000006</c:v>
                </c:pt>
                <c:pt idx="8">
                  <c:v>69.19957500000001</c:v>
                </c:pt>
                <c:pt idx="9">
                  <c:v>-33.119574999999998</c:v>
                </c:pt>
                <c:pt idx="10">
                  <c:v>2.7319249999999968</c:v>
                </c:pt>
                <c:pt idx="11">
                  <c:v>-6.5797250000000034</c:v>
                </c:pt>
                <c:pt idx="12">
                  <c:v>3.8453000000000017</c:v>
                </c:pt>
                <c:pt idx="13">
                  <c:v>30.169174999999996</c:v>
                </c:pt>
                <c:pt idx="14">
                  <c:v>-3.8832749999999905</c:v>
                </c:pt>
                <c:pt idx="15">
                  <c:v>7.7588000000000079</c:v>
                </c:pt>
                <c:pt idx="16">
                  <c:v>10.416974999999994</c:v>
                </c:pt>
                <c:pt idx="17">
                  <c:v>5.9338750000000005</c:v>
                </c:pt>
                <c:pt idx="18">
                  <c:v>89.920725000000004</c:v>
                </c:pt>
                <c:pt idx="19">
                  <c:v>18.344724999999997</c:v>
                </c:pt>
                <c:pt idx="20">
                  <c:v>-17.159825000000001</c:v>
                </c:pt>
                <c:pt idx="21">
                  <c:v>31.480399999999996</c:v>
                </c:pt>
                <c:pt idx="22">
                  <c:v>-9.0292249999999967</c:v>
                </c:pt>
                <c:pt idx="23">
                  <c:v>-35.68057499999999</c:v>
                </c:pt>
                <c:pt idx="24">
                  <c:v>12.789600000000007</c:v>
                </c:pt>
                <c:pt idx="25">
                  <c:v>-21.356425000000002</c:v>
                </c:pt>
                <c:pt idx="26">
                  <c:v>-39.595724999999995</c:v>
                </c:pt>
                <c:pt idx="27">
                  <c:v>-13.524874999999994</c:v>
                </c:pt>
                <c:pt idx="28">
                  <c:v>0.67902499999999577</c:v>
                </c:pt>
                <c:pt idx="29">
                  <c:v>-3.5313250000000025</c:v>
                </c:pt>
                <c:pt idx="30">
                  <c:v>-1.883899999999997</c:v>
                </c:pt>
                <c:pt idx="31">
                  <c:v>-12.468525</c:v>
                </c:pt>
                <c:pt idx="32">
                  <c:v>-18.366474999999994</c:v>
                </c:pt>
                <c:pt idx="33">
                  <c:v>-2.644299999999987</c:v>
                </c:pt>
                <c:pt idx="34">
                  <c:v>-28.327224999999999</c:v>
                </c:pt>
                <c:pt idx="35">
                  <c:v>-35.5377249999999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515-46A9-8EE9-49E4269426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69123616"/>
        <c:axId val="2069115296"/>
      </c:scatterChart>
      <c:valAx>
        <c:axId val="2069123616"/>
        <c:scaling>
          <c:orientation val="minMax"/>
          <c:max val="10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69115296"/>
        <c:crosses val="autoZero"/>
        <c:crossBetween val="midCat"/>
        <c:majorUnit val="25"/>
      </c:valAx>
      <c:valAx>
        <c:axId val="2069115296"/>
        <c:scaling>
          <c:orientation val="minMax"/>
          <c:min val="-8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69123616"/>
        <c:crosses val="autoZero"/>
        <c:crossBetween val="midCat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5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4" y="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622802" y="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DD47CF-8718-4BBB-9A19-6D25695E1E21}" type="datetimeFigureOut">
              <a:rPr kumimoji="1" lang="ja-JP" altLang="en-US" smtClean="0"/>
              <a:t>2021/8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4" y="6456613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622802" y="6456613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0F1477-D2F2-441D-AE44-A9B91BD8180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9981840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125" cy="341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2925" y="0"/>
            <a:ext cx="4302125" cy="341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C95E90-A3C3-43CF-AF3D-7A7C9741843C}" type="datetimeFigureOut">
              <a:rPr kumimoji="1" lang="ja-JP" altLang="en-US" smtClean="0"/>
              <a:t>2021/8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433763" y="849313"/>
            <a:ext cx="3059112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2188" y="3271838"/>
            <a:ext cx="7942262" cy="26765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56363"/>
            <a:ext cx="4302125" cy="341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2925" y="6456363"/>
            <a:ext cx="4302125" cy="341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376DC-9707-4A0E-8409-87C305F919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8257633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CFA6F-133A-4C6E-8FD1-E879DE42ABF8}" type="datetime1">
              <a:rPr kumimoji="1" lang="ja-JP" altLang="en-US" smtClean="0"/>
              <a:t>2021/8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6E8F8-DE86-4BA7-85A6-DD09C44B33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9515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3E765-0FEB-47A0-972B-26538184AEFF}" type="datetime1">
              <a:rPr kumimoji="1" lang="ja-JP" altLang="en-US" smtClean="0"/>
              <a:t>2021/8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6E8F8-DE86-4BA7-85A6-DD09C44B33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86767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A784D-8DF5-402B-A754-E4A3ADCDAC45}" type="datetime1">
              <a:rPr kumimoji="1" lang="ja-JP" altLang="en-US" smtClean="0"/>
              <a:t>2021/8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6E8F8-DE86-4BA7-85A6-DD09C44B33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7676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909E19-8B39-4EC6-A892-10028B1416A2}" type="datetime1">
              <a:rPr kumimoji="1" lang="ja-JP" altLang="en-US" smtClean="0"/>
              <a:t>2021/8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6E8F8-DE86-4BA7-85A6-DD09C44B33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9356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FD9D4-50B2-4805-9FAF-44CC452FC103}" type="datetime1">
              <a:rPr kumimoji="1" lang="ja-JP" altLang="en-US" smtClean="0"/>
              <a:t>2021/8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6E8F8-DE86-4BA7-85A6-DD09C44B33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1478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50E43-8F09-45C0-9CAA-E14D1FDDD8ED}" type="datetime1">
              <a:rPr kumimoji="1" lang="ja-JP" altLang="en-US" smtClean="0"/>
              <a:t>2021/8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6E8F8-DE86-4BA7-85A6-DD09C44B33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9494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49F51-0366-477F-BED2-C6B48F6A2024}" type="datetime1">
              <a:rPr kumimoji="1" lang="ja-JP" altLang="en-US" smtClean="0"/>
              <a:t>2021/8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6E8F8-DE86-4BA7-85A6-DD09C44B33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6907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C0A92-695B-474F-86FE-935AE1B5721E}" type="datetime1">
              <a:rPr kumimoji="1" lang="ja-JP" altLang="en-US" smtClean="0"/>
              <a:t>2021/8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6E8F8-DE86-4BA7-85A6-DD09C44B33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0139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DC3899-EBEB-4A2F-ACC9-B17BC6240FFD}" type="datetime1">
              <a:rPr kumimoji="1" lang="ja-JP" altLang="en-US" smtClean="0"/>
              <a:t>2021/8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6E8F8-DE86-4BA7-85A6-DD09C44B33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88591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296334-DE25-41FF-B9F3-C40E54A62EC2}" type="datetime1">
              <a:rPr kumimoji="1" lang="ja-JP" altLang="en-US" smtClean="0"/>
              <a:t>2021/8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6E8F8-DE86-4BA7-85A6-DD09C44B33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49819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E5BD7-1BEF-49AB-AD47-519D711C47B9}" type="datetime1">
              <a:rPr kumimoji="1" lang="ja-JP" altLang="en-US" smtClean="0"/>
              <a:t>2021/8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6E8F8-DE86-4BA7-85A6-DD09C44B33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5930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C425A5-0726-4374-B59D-3CE3B7C15E5F}" type="datetime1">
              <a:rPr kumimoji="1" lang="ja-JP" altLang="en-US" smtClean="0"/>
              <a:t>2021/8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6E8F8-DE86-4BA7-85A6-DD09C44B33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1461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1655249"/>
              </p:ext>
            </p:extLst>
          </p:nvPr>
        </p:nvGraphicFramePr>
        <p:xfrm>
          <a:off x="5003982" y="2169059"/>
          <a:ext cx="3007540" cy="28870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85499323"/>
              </p:ext>
            </p:extLst>
          </p:nvPr>
        </p:nvGraphicFramePr>
        <p:xfrm>
          <a:off x="1124107" y="2169059"/>
          <a:ext cx="3007540" cy="28870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正方形/長方形 6"/>
          <p:cNvSpPr/>
          <p:nvPr/>
        </p:nvSpPr>
        <p:spPr>
          <a:xfrm rot="16200000">
            <a:off x="-372455" y="3420585"/>
            <a:ext cx="2993127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5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dirty="0"/>
              <a:t>Deviation of root surface area at each </a:t>
            </a:r>
            <a:r>
              <a:rPr lang="en-US" altLang="ja-JP" dirty="0" smtClean="0"/>
              <a:t>location </a:t>
            </a:r>
            <a:r>
              <a:rPr lang="en-US" altLang="ja-JP" dirty="0"/>
              <a:t>(cm</a:t>
            </a:r>
            <a:r>
              <a:rPr lang="en-US" altLang="ja-JP" baseline="30000" dirty="0"/>
              <a:t>2</a:t>
            </a:r>
            <a:r>
              <a:rPr lang="en-US" altLang="ja-JP" dirty="0"/>
              <a:t>)</a:t>
            </a:r>
            <a:endParaRPr lang="ja-JP" altLang="ja-JP" dirty="0"/>
          </a:p>
        </p:txBody>
      </p:sp>
      <p:sp>
        <p:nvSpPr>
          <p:cNvPr id="8" name="正方形/長方形 7"/>
          <p:cNvSpPr/>
          <p:nvPr/>
        </p:nvSpPr>
        <p:spPr>
          <a:xfrm rot="16200000">
            <a:off x="3457148" y="3420584"/>
            <a:ext cx="3017173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5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dirty="0"/>
              <a:t>Deviation of root surface area at each location (cm</a:t>
            </a:r>
            <a:r>
              <a:rPr lang="en-US" altLang="ja-JP" baseline="30000" dirty="0"/>
              <a:t>2</a:t>
            </a:r>
            <a:r>
              <a:rPr lang="en-US" altLang="ja-JP" dirty="0"/>
              <a:t>)</a:t>
            </a:r>
            <a:endParaRPr lang="ja-JP" altLang="ja-JP" dirty="0"/>
          </a:p>
        </p:txBody>
      </p:sp>
      <p:sp>
        <p:nvSpPr>
          <p:cNvPr id="9" name="正方形/長方形 8"/>
          <p:cNvSpPr/>
          <p:nvPr/>
        </p:nvSpPr>
        <p:spPr>
          <a:xfrm>
            <a:off x="5209618" y="4967289"/>
            <a:ext cx="2654893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5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dirty="0" err="1"/>
              <a:t>Mycorrhizal</a:t>
            </a:r>
            <a:r>
              <a:rPr lang="en-US" altLang="ja-JP" dirty="0"/>
              <a:t> colonization at each location (%)</a:t>
            </a:r>
            <a:endParaRPr lang="ja-JP" altLang="ja-JP" dirty="0"/>
          </a:p>
        </p:txBody>
      </p:sp>
      <p:sp>
        <p:nvSpPr>
          <p:cNvPr id="10" name="正方形/長方形 9"/>
          <p:cNvSpPr/>
          <p:nvPr/>
        </p:nvSpPr>
        <p:spPr>
          <a:xfrm>
            <a:off x="1337468" y="4967289"/>
            <a:ext cx="2654893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5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dirty="0" err="1"/>
              <a:t>Mycorrhizal</a:t>
            </a:r>
            <a:r>
              <a:rPr lang="en-US" altLang="ja-JP" dirty="0"/>
              <a:t> colonization at each location (%)</a:t>
            </a:r>
            <a:endParaRPr lang="ja-JP" altLang="ja-JP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619482" y="1943271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433087" y="1943271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1767757" y="2240438"/>
            <a:ext cx="1812360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 sz="1050" b="0" i="0" u="none" strike="noStrike" kern="1200" baseline="0">
                <a:solidFill>
                  <a:prstClr val="black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i="1" dirty="0"/>
              <a:t>y</a:t>
            </a:r>
            <a:r>
              <a:rPr lang="en-US" altLang="ja-JP" dirty="0"/>
              <a:t> = </a:t>
            </a:r>
            <a:r>
              <a:rPr lang="en-US" altLang="ja-JP" dirty="0" smtClean="0"/>
              <a:t>0.43</a:t>
            </a:r>
            <a:r>
              <a:rPr lang="en-US" altLang="ja-JP" i="1" dirty="0" smtClean="0"/>
              <a:t>x</a:t>
            </a:r>
            <a:r>
              <a:rPr lang="en-US" altLang="ja-JP" dirty="0" smtClean="0"/>
              <a:t> </a:t>
            </a:r>
            <a:r>
              <a:rPr lang="en-US" altLang="ja-JP" dirty="0"/>
              <a:t>- </a:t>
            </a:r>
            <a:r>
              <a:rPr lang="en-US" altLang="ja-JP" dirty="0" smtClean="0"/>
              <a:t>24.8</a:t>
            </a:r>
            <a:r>
              <a:rPr lang="en-US" altLang="ja-JP" dirty="0"/>
              <a:t/>
            </a:r>
            <a:br>
              <a:rPr lang="en-US" altLang="ja-JP" dirty="0"/>
            </a:br>
            <a:r>
              <a:rPr lang="en-US" altLang="ja-JP" i="1" dirty="0"/>
              <a:t>R²</a:t>
            </a:r>
            <a:r>
              <a:rPr lang="en-US" altLang="ja-JP" dirty="0"/>
              <a:t> = </a:t>
            </a:r>
            <a:r>
              <a:rPr lang="en-US" altLang="ja-JP" dirty="0" smtClean="0"/>
              <a:t>0.2416, </a:t>
            </a:r>
            <a:r>
              <a:rPr lang="en-US" altLang="ja-JP" i="1" dirty="0" smtClean="0"/>
              <a:t>n</a:t>
            </a:r>
            <a:r>
              <a:rPr lang="en-US" altLang="ja-JP" dirty="0" smtClean="0"/>
              <a:t> =36, </a:t>
            </a:r>
            <a:r>
              <a:rPr lang="en-US" altLang="ja-JP" i="1" dirty="0" smtClean="0"/>
              <a:t>P</a:t>
            </a:r>
            <a:r>
              <a:rPr lang="en-US" altLang="ja-JP" dirty="0" smtClean="0"/>
              <a:t> &lt; 0.01</a:t>
            </a:r>
            <a:endParaRPr lang="en-US" altLang="ja-JP" dirty="0"/>
          </a:p>
        </p:txBody>
      </p:sp>
      <p:sp>
        <p:nvSpPr>
          <p:cNvPr id="14" name="正方形/長方形 13"/>
          <p:cNvSpPr/>
          <p:nvPr/>
        </p:nvSpPr>
        <p:spPr>
          <a:xfrm>
            <a:off x="5718317" y="2240438"/>
            <a:ext cx="2146194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 sz="1050" b="0" i="0" u="none" strike="noStrike" kern="1200" baseline="0">
                <a:solidFill>
                  <a:prstClr val="black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i="1" dirty="0"/>
              <a:t>y</a:t>
            </a:r>
            <a:r>
              <a:rPr lang="en-US" altLang="ja-JP" dirty="0"/>
              <a:t> = </a:t>
            </a:r>
            <a:r>
              <a:rPr lang="en-US" altLang="ja-JP" dirty="0" smtClean="0"/>
              <a:t>0.36</a:t>
            </a:r>
            <a:r>
              <a:rPr lang="en-US" altLang="ja-JP" i="1" dirty="0" smtClean="0"/>
              <a:t>x</a:t>
            </a:r>
            <a:r>
              <a:rPr lang="en-US" altLang="ja-JP" dirty="0" smtClean="0"/>
              <a:t> </a:t>
            </a:r>
            <a:r>
              <a:rPr lang="en-US" altLang="ja-JP" dirty="0"/>
              <a:t>- </a:t>
            </a:r>
            <a:r>
              <a:rPr lang="en-US" altLang="ja-JP" dirty="0" smtClean="0"/>
              <a:t>13.6</a:t>
            </a:r>
            <a:r>
              <a:rPr lang="en-US" altLang="ja-JP" dirty="0"/>
              <a:t/>
            </a:r>
            <a:br>
              <a:rPr lang="en-US" altLang="ja-JP" dirty="0"/>
            </a:br>
            <a:r>
              <a:rPr lang="en-US" altLang="ja-JP" i="1" dirty="0"/>
              <a:t>R²</a:t>
            </a:r>
            <a:r>
              <a:rPr lang="en-US" altLang="ja-JP" dirty="0"/>
              <a:t> = </a:t>
            </a:r>
            <a:r>
              <a:rPr lang="en-US" altLang="ja-JP" dirty="0" smtClean="0"/>
              <a:t>0.1569, </a:t>
            </a:r>
            <a:r>
              <a:rPr lang="en-US" altLang="ja-JP" i="1" dirty="0" smtClean="0"/>
              <a:t>n</a:t>
            </a:r>
            <a:r>
              <a:rPr lang="en-US" altLang="ja-JP" dirty="0" smtClean="0"/>
              <a:t> = 36, </a:t>
            </a:r>
            <a:r>
              <a:rPr lang="en-US" altLang="ja-JP" i="1" dirty="0" smtClean="0"/>
              <a:t>P</a:t>
            </a:r>
            <a:r>
              <a:rPr lang="en-US" altLang="ja-JP" dirty="0" smtClean="0"/>
              <a:t> &lt; 0.05</a:t>
            </a:r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40178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50</TotalTime>
  <Words>50</Words>
  <Application>Microsoft Office PowerPoint</Application>
  <PresentationFormat>画面に合わせる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 Koyama</dc:creator>
  <cp:lastModifiedBy>T Koyama</cp:lastModifiedBy>
  <cp:revision>198</cp:revision>
  <cp:lastPrinted>2021-03-16T13:00:05Z</cp:lastPrinted>
  <dcterms:created xsi:type="dcterms:W3CDTF">2020-01-28T10:02:04Z</dcterms:created>
  <dcterms:modified xsi:type="dcterms:W3CDTF">2021-08-27T00:49:25Z</dcterms:modified>
</cp:coreProperties>
</file>